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A4931-9BC2-4432-9CFD-E3244369AA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556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5E9E0-49D6-4C8F-9AAB-EA00883DB9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06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503A5-E97D-4CE2-962D-14434D00A8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08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536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08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536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98902-E35C-4FF1-AB71-6B036294E9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317ED-54ED-40C7-A952-8E343DA1A2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BDEC2B-1AD1-4297-9C55-7B60D21AFD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985FD6-F220-47B1-963C-08FF002BC4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B7449-B5C0-4351-91EE-D4638C7772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920"/>
            <a:ext cx="5827680" cy="764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9DF960-F1EE-47D5-8759-7D005415FD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B1592-5421-4123-87E4-F96887611B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06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21904-E856-4FD0-8AE1-438823FE63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094BD-8B73-4E7E-A7E3-9C44408CB5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440" y="9024840"/>
            <a:ext cx="142704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840"/>
            <a:ext cx="217008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840"/>
            <a:ext cx="142704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79E294CA-F72E-47E2-9001-F598D39D00F3}" type="slidenum"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577880" y="4265640"/>
            <a:ext cx="4019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1577880" y="3798720"/>
            <a:ext cx="4019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577880" y="3341520"/>
            <a:ext cx="4019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1577880" y="2884320"/>
            <a:ext cx="4019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1577880" y="2417760"/>
            <a:ext cx="4019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1577880" y="1960560"/>
            <a:ext cx="4019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577880" y="1960560"/>
            <a:ext cx="4019760" cy="276228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073320" y="2408400"/>
            <a:ext cx="209520" cy="2314440"/>
          </a:xfrm>
          <a:prstGeom prst="rect">
            <a:avLst/>
          </a:prstGeom>
          <a:solidFill>
            <a:srgbClr val="99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406760" y="2436840"/>
            <a:ext cx="209520" cy="2286000"/>
          </a:xfrm>
          <a:prstGeom prst="rect">
            <a:avLst/>
          </a:prstGeom>
          <a:solidFill>
            <a:srgbClr val="99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1940040" y="4265640"/>
            <a:ext cx="209520" cy="457200"/>
          </a:xfrm>
          <a:prstGeom prst="rect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3282840" y="4065480"/>
            <a:ext cx="200160" cy="657360"/>
          </a:xfrm>
          <a:prstGeom prst="rect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4616280" y="3903840"/>
            <a:ext cx="209880" cy="819000"/>
          </a:xfrm>
          <a:prstGeom prst="rect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2149560" y="4265640"/>
            <a:ext cx="199800" cy="457200"/>
          </a:xfrm>
          <a:prstGeom prst="rect">
            <a:avLst/>
          </a:prstGeom>
          <a:solidFill>
            <a:srgbClr val="ff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483000" y="4027320"/>
            <a:ext cx="209520" cy="695520"/>
          </a:xfrm>
          <a:prstGeom prst="rect">
            <a:avLst/>
          </a:prstGeom>
          <a:solidFill>
            <a:srgbClr val="ff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826160" y="3703680"/>
            <a:ext cx="199800" cy="1019160"/>
          </a:xfrm>
          <a:prstGeom prst="rect">
            <a:avLst/>
          </a:prstGeom>
          <a:solidFill>
            <a:srgbClr val="ff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2349360" y="4265640"/>
            <a:ext cx="209520" cy="457200"/>
          </a:xfrm>
          <a:prstGeom prst="rect">
            <a:avLst/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3692520" y="3541680"/>
            <a:ext cx="200160" cy="1181160"/>
          </a:xfrm>
          <a:prstGeom prst="rect">
            <a:avLst/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5025960" y="3532320"/>
            <a:ext cx="209520" cy="1190520"/>
          </a:xfrm>
          <a:prstGeom prst="rect">
            <a:avLst/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2558880" y="4265640"/>
            <a:ext cx="209880" cy="45720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3892680" y="4332240"/>
            <a:ext cx="209520" cy="39060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5235480" y="4208400"/>
            <a:ext cx="209520" cy="51444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3178080" y="2387520"/>
            <a:ext cx="180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3149640" y="238932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4511520" y="2406600"/>
            <a:ext cx="1800" cy="3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4483080" y="240840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3178080" y="2408400"/>
            <a:ext cx="1800" cy="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3149640" y="24177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511520" y="2436840"/>
            <a:ext cx="180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483080" y="247500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2044800" y="422604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2016000" y="4227480"/>
            <a:ext cx="66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 flipV="1">
            <a:off x="3378240" y="4035600"/>
            <a:ext cx="1440" cy="3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349800" y="403704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 flipV="1">
            <a:off x="4721400" y="3863520"/>
            <a:ext cx="144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692600" y="386568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2044800" y="4265640"/>
            <a:ext cx="144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2016000" y="4303800"/>
            <a:ext cx="66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3378240" y="4065480"/>
            <a:ext cx="144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3349800" y="410364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4721400" y="3903840"/>
            <a:ext cx="144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4692600" y="39513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2244600" y="4244760"/>
            <a:ext cx="1800" cy="21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2216160" y="424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3587760" y="400680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3559320" y="400860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 flipV="1">
            <a:off x="4921200" y="3664080"/>
            <a:ext cx="180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4892760" y="366552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2244600" y="4265640"/>
            <a:ext cx="1800" cy="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2216160" y="427500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3587760" y="4027320"/>
            <a:ext cx="1440" cy="1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3559320" y="404640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4921200" y="3703680"/>
            <a:ext cx="180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4892760" y="374184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 flipV="1">
            <a:off x="2454120" y="4235400"/>
            <a:ext cx="1800" cy="3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2425680" y="423720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 flipV="1">
            <a:off x="3787920" y="3511080"/>
            <a:ext cx="1440" cy="32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3759120" y="351324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 flipV="1">
            <a:off x="5130720" y="3492000"/>
            <a:ext cx="180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5102280" y="34941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2454120" y="4265640"/>
            <a:ext cx="180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2425680" y="429408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3787920" y="3541680"/>
            <a:ext cx="144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3759120" y="358920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5130720" y="3532320"/>
            <a:ext cx="1800" cy="56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5102280" y="358920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2664000" y="4244760"/>
            <a:ext cx="1440" cy="21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2635200" y="424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3997440" y="4311720"/>
            <a:ext cx="1440" cy="2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3968640" y="4313160"/>
            <a:ext cx="66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5340240" y="4149720"/>
            <a:ext cx="1800" cy="60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5311800" y="415116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2664000" y="4265640"/>
            <a:ext cx="1440" cy="1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2635200" y="428472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3997440" y="4332240"/>
            <a:ext cx="1440" cy="1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3968640" y="4351320"/>
            <a:ext cx="66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5340240" y="4208400"/>
            <a:ext cx="180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5311800" y="428472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1577880" y="1960560"/>
            <a:ext cx="1800" cy="276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1539720" y="4722840"/>
            <a:ext cx="38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1539720" y="4265640"/>
            <a:ext cx="38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1539720" y="3798720"/>
            <a:ext cx="381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1539720" y="3341520"/>
            <a:ext cx="381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1539720" y="2884320"/>
            <a:ext cx="381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1539720" y="2417760"/>
            <a:ext cx="38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1539720" y="1960560"/>
            <a:ext cx="38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1577880" y="4722840"/>
            <a:ext cx="4019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1577880" y="4721400"/>
            <a:ext cx="180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2921040" y="472140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4254480" y="472140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 flipV="1">
            <a:off x="5597640" y="472140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1411560" y="4648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1411560" y="41911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1344960" y="37242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1278000" y="32670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1211400" y="280980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1143000" y="2343240"/>
            <a:ext cx="351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1076040" y="1886040"/>
            <a:ext cx="421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0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2158920" y="4827600"/>
            <a:ext cx="20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Col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3386160" y="482760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120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4730760" y="482760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120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 rot="16200000">
            <a:off x="455760" y="3753000"/>
            <a:ext cx="1349640" cy="15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Expression level (log</a:t>
            </a:r>
            <a:r>
              <a:rPr b="1" lang="es-ES_tradnl" sz="1000" spc="-1" strike="noStrike" baseline="-14000">
                <a:solidFill>
                  <a:srgbClr val="000000"/>
                </a:solidFill>
                <a:latin typeface="Arial"/>
              </a:rPr>
              <a:t>2</a:t>
            </a: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)</a:t>
            </a: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‏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4892760" y="2084400"/>
            <a:ext cx="609480" cy="10000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4940280" y="2160720"/>
            <a:ext cx="66600" cy="66600"/>
          </a:xfrm>
          <a:prstGeom prst="rect">
            <a:avLst/>
          </a:prstGeom>
          <a:solidFill>
            <a:srgbClr val="99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800" bIns="19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5045040" y="2112840"/>
            <a:ext cx="421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citrSEP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4940280" y="2360520"/>
            <a:ext cx="66600" cy="66600"/>
          </a:xfrm>
          <a:prstGeom prst="rect">
            <a:avLst/>
          </a:prstGeom>
          <a:solidFill>
            <a:srgbClr val="9933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800" bIns="19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5045040" y="2313000"/>
            <a:ext cx="32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SEP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4940280" y="2560680"/>
            <a:ext cx="66600" cy="66600"/>
          </a:xfrm>
          <a:prstGeom prst="rect">
            <a:avLst/>
          </a:prstGeom>
          <a:solidFill>
            <a:srgbClr val="ff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800" bIns="19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5045040" y="2513160"/>
            <a:ext cx="32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SEP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4940280" y="2760840"/>
            <a:ext cx="66600" cy="66600"/>
          </a:xfrm>
          <a:prstGeom prst="rect">
            <a:avLst/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800" bIns="19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5045040" y="2712960"/>
            <a:ext cx="32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SEP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4940280" y="2960640"/>
            <a:ext cx="66600" cy="66600"/>
          </a:xfrm>
          <a:prstGeom prst="rect">
            <a:avLst/>
          </a:prstGeom>
          <a:solidFill>
            <a:srgbClr val="66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800" bIns="19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5045040" y="2913120"/>
            <a:ext cx="32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SEP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 rot="16200000">
            <a:off x="1635120" y="445680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nd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193320" y="633240"/>
            <a:ext cx="652392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dditional file 7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Expression analysis of transgenic Arabidopsis plants that overexpress th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itrSE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gene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Expression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itrSE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and four endogenous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EPALLAT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genes, analyzed by qRT-PCR, was normalized to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he expression of the constitutiv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EF-1-α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gene and then to the expression in Col-0 plants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For normalization purposes, the detection level of our qRT-PCR analysis was used as an estimat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of th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itrSE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expression in Col-0. Expression level is indicated in the plot.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nd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not detected.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pereza</cp:lastModifiedBy>
  <dcterms:modified xsi:type="dcterms:W3CDTF">2009-09-08T07:18:03Z</dcterms:modified>
  <cp:revision>4</cp:revision>
  <dc:subject/>
  <dc:title>PowerPoint Presentation</dc:title>
</cp:coreProperties>
</file>